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0E96D-62AF-4EAE-84F1-9E486D5376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AD7FF3-D97F-4480-84BE-033A45AC6C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0F17AC-C0CD-46C2-A040-67509B3DF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A8C34-0EBB-4A18-911C-F5DABD782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D92AE7-4219-4696-AA60-5237731BA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36038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0FC28-89FA-456C-A410-7057BDC11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CF1B08-0667-4FAB-9AAA-6192B8FB12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983D51-BFC4-4081-B728-A9AAC440C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97B2F0-89AE-4A8E-9D2A-8E8FC5590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81D15-3B08-4EA1-9582-CC12B1AFD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13724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3DEE32-405D-4D59-84AD-8CAC3D767E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9E0615-BC82-4203-93B8-3F85EFF32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2ACF8B-911D-4A24-AE83-ABA20CD6A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34249-8B15-469E-B4C1-19F678852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CFC5AC-BEEE-4137-AAF6-3F9FC9BB4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2951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DED57-A391-4007-AA2A-B3D3F2F3E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849036-A366-4D3F-93F9-ABB833D447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5C1305-3E35-4D8A-9F8F-E76C67271B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5B3A16-8615-44E1-A629-16A944A13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EDBEBD-0C29-4D16-974E-973C648AA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8995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866C0-B03A-4A6E-9573-2CFC100705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56DA7B-6079-4075-A1FF-25BEB8963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D1C3C-B504-46D6-AE12-53AABE35B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717EC-EC5F-4E14-8FE0-BC7B2EAB4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D876D1-EEA3-4E82-ADEA-2D57EACDD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9460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D46D6-31FF-4128-A5A9-BCBA2E478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BB5B5D-FFA6-4747-BDBE-1EE580B5C5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A71BAE-A2BA-43CA-BC12-90D3BEC46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B75B00-86FB-48B8-B5F0-822592FC9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AB010C-4010-4A57-B04F-0D75D57E5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66C7AC-3B1F-4FA3-AFC8-D9CDE75C1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3283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92A79F-D6FA-413C-8FB5-4F11CCE36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6FAC1-FB47-455D-A4AC-78E91DCE39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BE00F4-A32C-4A8A-A0C8-789FF02D80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65DF86-C7E4-4447-BE31-23B7A9AE37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232E88-2762-420A-A4DB-49C849C7BF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8670B1-6162-4078-9C2C-831686E6B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095090-8229-4A27-A392-EC02F8FE6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DB668C-4269-488C-8AB7-BF647F6F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34171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D36B5-36AE-4C76-BD68-430CDE9B6A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AA22880-01F9-4852-9047-815DF293E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421409-3D09-4282-AD22-C11480F1D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9B0BB4-2FD1-453A-B2C1-7F674C95A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9395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22EFBE-495A-45DD-A532-B61E1E37B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9CC45E-F302-4528-8335-2D4566019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36C527-1DCD-4E87-A604-7667DC78F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8199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1E6B2-1A3E-477F-AF19-C71A4BE82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EB74E-BAE5-42A2-A332-767C32303E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5A8204-73D0-41BB-88CC-D455B56505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50FB99-6146-4655-AA3F-D154F45BE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E854CA-0CAF-488B-B2DF-A6DDAD565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CA9281-B20C-4834-8EA5-C99357439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70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972A2-F143-40AE-876E-801968F8DA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0E1ADD-3AA7-4E1B-9366-A54DF7A054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DFD4BE-09E5-4BF7-A8B6-18D8974846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6D96D3-A9F4-47EA-B115-9A64D07EB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B0CA92-A920-4E89-88E1-6687DAD38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0AB2E7-40DC-48B3-BBBB-FDD0FC07F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388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FAB777-E9D6-4A01-A176-412DE3E622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AC5F32-DAB5-428F-959D-9B4D21791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AF31A-CF2A-4ABA-AF43-24E38DE644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410FF-B7E2-4EF4-81D5-C0C3048D7071}" type="datetimeFigureOut">
              <a:rPr lang="en-AU" smtClean="0"/>
              <a:t>23/6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41DACB-A0D8-4A70-8D40-8B80429FC9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D73DDD-4B6E-4887-A3D1-175AAB80F4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D15FD-13E8-4FEF-A1BF-552686EBFBA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4765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90432D8-A818-44CF-8FBE-BF2E90926A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053" y="990888"/>
            <a:ext cx="5210902" cy="38295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5E575DC-E5AE-479C-9D5B-EC0EC64ECCC5}"/>
              </a:ext>
            </a:extLst>
          </p:cNvPr>
          <p:cNvSpPr txBox="1"/>
          <p:nvPr/>
        </p:nvSpPr>
        <p:spPr>
          <a:xfrm>
            <a:off x="1219200" y="344557"/>
            <a:ext cx="95945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Oh My……. IT WORKED!!!!</a:t>
            </a:r>
          </a:p>
          <a:p>
            <a:r>
              <a:rPr lang="en-AU" dirty="0"/>
              <a:t>17/5/23 Cathepsin H 2</a:t>
            </a:r>
            <a:r>
              <a:rPr lang="en-AU" baseline="30000" dirty="0"/>
              <a:t>nd</a:t>
            </a:r>
            <a:r>
              <a:rPr lang="en-AU" dirty="0"/>
              <a:t> Antibody Cat No:PA55195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2D3AD92-7830-45E5-9C18-F48F90875F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053" y="5220781"/>
            <a:ext cx="8264849" cy="1553706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BE79775-D59A-43A1-8EB0-3FAB2C2B09DA}"/>
              </a:ext>
            </a:extLst>
          </p:cNvPr>
          <p:cNvCxnSpPr/>
          <p:nvPr/>
        </p:nvCxnSpPr>
        <p:spPr>
          <a:xfrm flipH="1">
            <a:off x="5791201" y="3591339"/>
            <a:ext cx="848139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66EBCC3-CF86-46CB-BAE4-F10FF812557F}"/>
              </a:ext>
            </a:extLst>
          </p:cNvPr>
          <p:cNvSpPr txBox="1"/>
          <p:nvPr/>
        </p:nvSpPr>
        <p:spPr>
          <a:xfrm>
            <a:off x="5909072" y="3591339"/>
            <a:ext cx="1683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/>
              <a:t>Approx</a:t>
            </a:r>
            <a:r>
              <a:rPr lang="en-AU" dirty="0"/>
              <a:t> 28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BDCEDA-8372-40AB-905B-8793C3BC428D}"/>
              </a:ext>
            </a:extLst>
          </p:cNvPr>
          <p:cNvSpPr txBox="1"/>
          <p:nvPr/>
        </p:nvSpPr>
        <p:spPr>
          <a:xfrm>
            <a:off x="0" y="3244334"/>
            <a:ext cx="469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2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A8D9CF-3C29-43EA-84A1-7AF2DCFCF6A1}"/>
              </a:ext>
            </a:extLst>
          </p:cNvPr>
          <p:cNvSpPr txBox="1"/>
          <p:nvPr/>
        </p:nvSpPr>
        <p:spPr>
          <a:xfrm>
            <a:off x="0" y="4259997"/>
            <a:ext cx="469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1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BCA180-B1AA-49A1-ADF1-4BDB0AC61018}"/>
              </a:ext>
            </a:extLst>
          </p:cNvPr>
          <p:cNvSpPr txBox="1"/>
          <p:nvPr/>
        </p:nvSpPr>
        <p:spPr>
          <a:xfrm>
            <a:off x="0" y="2413337"/>
            <a:ext cx="469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3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DA32D1-A075-4F50-9830-5C0A38577B25}"/>
              </a:ext>
            </a:extLst>
          </p:cNvPr>
          <p:cNvSpPr txBox="1"/>
          <p:nvPr/>
        </p:nvSpPr>
        <p:spPr>
          <a:xfrm>
            <a:off x="561818" y="4851449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225F6B-7847-445F-AA0B-02C22A30EE45}"/>
              </a:ext>
            </a:extLst>
          </p:cNvPr>
          <p:cNvSpPr txBox="1"/>
          <p:nvPr/>
        </p:nvSpPr>
        <p:spPr>
          <a:xfrm>
            <a:off x="1126433" y="4851449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F09D6DD-278F-4960-956D-74332BA442D9}"/>
              </a:ext>
            </a:extLst>
          </p:cNvPr>
          <p:cNvSpPr txBox="1"/>
          <p:nvPr/>
        </p:nvSpPr>
        <p:spPr>
          <a:xfrm>
            <a:off x="1691048" y="4862753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4D3885-F745-43DD-A609-C8C89DE2664F}"/>
              </a:ext>
            </a:extLst>
          </p:cNvPr>
          <p:cNvSpPr txBox="1"/>
          <p:nvPr/>
        </p:nvSpPr>
        <p:spPr>
          <a:xfrm>
            <a:off x="2801797" y="4847265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037852-AB7F-4913-ADB9-328C4DD0706C}"/>
              </a:ext>
            </a:extLst>
          </p:cNvPr>
          <p:cNvSpPr txBox="1"/>
          <p:nvPr/>
        </p:nvSpPr>
        <p:spPr>
          <a:xfrm>
            <a:off x="3361183" y="4843849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692C93-9D6D-412A-9784-E87D70A10F19}"/>
              </a:ext>
            </a:extLst>
          </p:cNvPr>
          <p:cNvSpPr txBox="1"/>
          <p:nvPr/>
        </p:nvSpPr>
        <p:spPr>
          <a:xfrm>
            <a:off x="4976549" y="4843849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8FAF5B5-C2CE-4D16-83BC-0B7C4E5D9B2B}"/>
              </a:ext>
            </a:extLst>
          </p:cNvPr>
          <p:cNvSpPr txBox="1"/>
          <p:nvPr/>
        </p:nvSpPr>
        <p:spPr>
          <a:xfrm>
            <a:off x="5467577" y="4849501"/>
            <a:ext cx="471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4F685E5-96E1-4BB5-9AE0-A22541764ADF}"/>
              </a:ext>
            </a:extLst>
          </p:cNvPr>
          <p:cNvSpPr txBox="1"/>
          <p:nvPr/>
        </p:nvSpPr>
        <p:spPr>
          <a:xfrm>
            <a:off x="2266293" y="4789794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1D352C3-F19D-4877-87B0-27ABFCA8E256}"/>
              </a:ext>
            </a:extLst>
          </p:cNvPr>
          <p:cNvSpPr txBox="1"/>
          <p:nvPr/>
        </p:nvSpPr>
        <p:spPr>
          <a:xfrm>
            <a:off x="3878007" y="4813508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212E0E-7FEC-4F98-BD4F-49B3184E92D0}"/>
              </a:ext>
            </a:extLst>
          </p:cNvPr>
          <p:cNvSpPr txBox="1"/>
          <p:nvPr/>
        </p:nvSpPr>
        <p:spPr>
          <a:xfrm>
            <a:off x="4489509" y="4820472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BE42399-D741-4482-8B0A-CF85C48A2F70}"/>
              </a:ext>
            </a:extLst>
          </p:cNvPr>
          <p:cNvSpPr txBox="1"/>
          <p:nvPr/>
        </p:nvSpPr>
        <p:spPr>
          <a:xfrm>
            <a:off x="6104202" y="4782956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C30B204-4151-434A-9BD5-4358E4BA1D2A}"/>
              </a:ext>
            </a:extLst>
          </p:cNvPr>
          <p:cNvSpPr txBox="1"/>
          <p:nvPr/>
        </p:nvSpPr>
        <p:spPr>
          <a:xfrm>
            <a:off x="6595230" y="4797682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4F0649-3675-484D-B210-F9BD47C5C00A}"/>
              </a:ext>
            </a:extLst>
          </p:cNvPr>
          <p:cNvSpPr txBox="1"/>
          <p:nvPr/>
        </p:nvSpPr>
        <p:spPr>
          <a:xfrm>
            <a:off x="7639012" y="4751516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ADAE2E3-B922-4F3F-9856-B8D2E5311732}"/>
              </a:ext>
            </a:extLst>
          </p:cNvPr>
          <p:cNvSpPr txBox="1"/>
          <p:nvPr/>
        </p:nvSpPr>
        <p:spPr>
          <a:xfrm>
            <a:off x="8250801" y="4751515"/>
            <a:ext cx="4289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dirty="0"/>
              <a:t>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842D237-7F9D-49BF-B597-3107224F08A4}"/>
              </a:ext>
            </a:extLst>
          </p:cNvPr>
          <p:cNvSpPr txBox="1"/>
          <p:nvPr/>
        </p:nvSpPr>
        <p:spPr>
          <a:xfrm>
            <a:off x="8209923" y="344557"/>
            <a:ext cx="3664025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Lane 1 : Size Ladder</a:t>
            </a:r>
          </a:p>
          <a:p>
            <a:r>
              <a:rPr lang="en-AU" dirty="0"/>
              <a:t>Lane 2 : HEPG2 cells</a:t>
            </a:r>
          </a:p>
          <a:p>
            <a:r>
              <a:rPr lang="en-AU" dirty="0"/>
              <a:t>Lane 3 : K562 cells</a:t>
            </a:r>
          </a:p>
          <a:p>
            <a:r>
              <a:rPr lang="en-AU" dirty="0"/>
              <a:t>Lane 4 : </a:t>
            </a:r>
            <a:r>
              <a:rPr lang="en-AU" dirty="0" err="1"/>
              <a:t>Jurkat</a:t>
            </a:r>
            <a:r>
              <a:rPr lang="en-AU" dirty="0"/>
              <a:t> cells</a:t>
            </a:r>
          </a:p>
          <a:p>
            <a:r>
              <a:rPr lang="en-AU" dirty="0"/>
              <a:t>Lane 5 : DMSO control 24/10/22</a:t>
            </a:r>
          </a:p>
          <a:p>
            <a:r>
              <a:rPr lang="en-AU" dirty="0"/>
              <a:t>Lane 6 : </a:t>
            </a:r>
            <a:r>
              <a:rPr lang="en-AU" dirty="0" err="1"/>
              <a:t>Brenso</a:t>
            </a:r>
            <a:r>
              <a:rPr lang="en-AU" dirty="0"/>
              <a:t> control 24/10/22</a:t>
            </a:r>
          </a:p>
          <a:p>
            <a:r>
              <a:rPr lang="en-AU" dirty="0"/>
              <a:t>Lane 7 : #3 BG DMSO 28/10/22</a:t>
            </a:r>
          </a:p>
          <a:p>
            <a:r>
              <a:rPr lang="en-AU" dirty="0"/>
              <a:t>Lane 8 : #3 BG </a:t>
            </a:r>
            <a:r>
              <a:rPr lang="en-AU" dirty="0" err="1"/>
              <a:t>Brenso</a:t>
            </a:r>
            <a:r>
              <a:rPr lang="en-AU" dirty="0"/>
              <a:t> 28/10/22</a:t>
            </a:r>
          </a:p>
          <a:p>
            <a:r>
              <a:rPr lang="en-AU" dirty="0"/>
              <a:t>Lane 9 : DMSO control 21/11/22</a:t>
            </a:r>
          </a:p>
          <a:p>
            <a:r>
              <a:rPr lang="en-AU" dirty="0"/>
              <a:t>Lane 10 : </a:t>
            </a:r>
            <a:r>
              <a:rPr lang="en-AU" dirty="0" err="1"/>
              <a:t>Brenso</a:t>
            </a:r>
            <a:r>
              <a:rPr lang="en-AU" dirty="0"/>
              <a:t> control 21/11/22</a:t>
            </a:r>
          </a:p>
          <a:p>
            <a:r>
              <a:rPr lang="en-AU" dirty="0"/>
              <a:t>Lane 11 : #2 DMSO 24/11/22</a:t>
            </a:r>
          </a:p>
          <a:p>
            <a:r>
              <a:rPr lang="en-AU" dirty="0"/>
              <a:t>Lane 12 : #3 </a:t>
            </a:r>
            <a:r>
              <a:rPr lang="en-AU" dirty="0" err="1"/>
              <a:t>Brenso</a:t>
            </a:r>
            <a:r>
              <a:rPr lang="en-AU" dirty="0"/>
              <a:t> 24/11/22</a:t>
            </a:r>
          </a:p>
          <a:p>
            <a:r>
              <a:rPr lang="en-AU" dirty="0"/>
              <a:t>Lane 13 : empty</a:t>
            </a:r>
          </a:p>
          <a:p>
            <a:r>
              <a:rPr lang="en-AU" dirty="0"/>
              <a:t>Lane 14 : #4 </a:t>
            </a:r>
            <a:r>
              <a:rPr lang="en-AU" dirty="0" err="1"/>
              <a:t>Brenso</a:t>
            </a:r>
            <a:r>
              <a:rPr lang="en-AU" dirty="0"/>
              <a:t> 24/11/22</a:t>
            </a:r>
          </a:p>
          <a:p>
            <a:r>
              <a:rPr lang="en-AU" dirty="0"/>
              <a:t>Lane 15 : #5 </a:t>
            </a:r>
            <a:r>
              <a:rPr lang="en-AU" dirty="0" err="1"/>
              <a:t>Brenso</a:t>
            </a:r>
            <a:r>
              <a:rPr lang="en-AU" dirty="0"/>
              <a:t> 24/11/22</a:t>
            </a:r>
          </a:p>
          <a:p>
            <a:endParaRPr lang="en-AU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6913862-8F76-4F93-8978-F906E33076AB}"/>
              </a:ext>
            </a:extLst>
          </p:cNvPr>
          <p:cNvSpPr txBox="1"/>
          <p:nvPr/>
        </p:nvSpPr>
        <p:spPr>
          <a:xfrm>
            <a:off x="561818" y="1113183"/>
            <a:ext cx="499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L  1    2    3    4    5     6    7    8    9   10  11  12  13  14</a:t>
            </a:r>
          </a:p>
        </p:txBody>
      </p:sp>
    </p:spTree>
    <p:extLst>
      <p:ext uri="{BB962C8B-B14F-4D97-AF65-F5344CB8AC3E}">
        <p14:creationId xmlns:p14="http://schemas.microsoft.com/office/powerpoint/2010/main" val="3618887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41</Words>
  <Application>Microsoft Macintosh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ly Watt</dc:creator>
  <cp:lastModifiedBy>Viv Sutton</cp:lastModifiedBy>
  <cp:revision>2</cp:revision>
  <dcterms:created xsi:type="dcterms:W3CDTF">2023-05-17T03:25:25Z</dcterms:created>
  <dcterms:modified xsi:type="dcterms:W3CDTF">2024-06-23T07:58:25Z</dcterms:modified>
</cp:coreProperties>
</file>